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2" d="100"/>
          <a:sy n="112" d="100"/>
        </p:scale>
        <p:origin x="-104" y="-2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tkowskiHE\Dropbox\My%20documents%20-%20Mac\Grant%20Applications\Salivary%20Glycomics\Ewa%20to%20Susan_Aug%2011\Official%201-13-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tkowskiHE\Dropbox\My%20documents%20-%20Mac\Grant%20Applications\Salivary%20Glycomics\Ewa%20to%20Susan_Aug%2011\Official%201-13-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S2_Glyco-nonglyco bins'!$AT$50</c:f>
              <c:strCache>
                <c:ptCount val="1"/>
                <c:pt idx="0">
                  <c:v>Nonsecretor</c:v>
                </c:pt>
              </c:strCache>
            </c:strRef>
          </c:tx>
          <c:cat>
            <c:strRef>
              <c:f>'S2_Glyco-nonglyco bins'!$AS$51:$AS$57</c:f>
              <c:strCache>
                <c:ptCount val="7"/>
                <c:pt idx="0">
                  <c:v>n=1</c:v>
                </c:pt>
                <c:pt idx="1">
                  <c:v>1&lt;n&lt;7</c:v>
                </c:pt>
                <c:pt idx="2">
                  <c:v>7&lt;n&lt;20</c:v>
                </c:pt>
                <c:pt idx="3">
                  <c:v>20&lt;n&lt;50</c:v>
                </c:pt>
                <c:pt idx="4">
                  <c:v>50&lt;n&lt;100</c:v>
                </c:pt>
                <c:pt idx="5">
                  <c:v>100&lt;n&lt;400</c:v>
                </c:pt>
                <c:pt idx="6">
                  <c:v>n&gt;400</c:v>
                </c:pt>
              </c:strCache>
            </c:strRef>
          </c:cat>
          <c:val>
            <c:numRef>
              <c:f>'S2_Glyco-nonglyco bins'!$AT$51:$AT$57</c:f>
              <c:numCache>
                <c:formatCode>General</c:formatCode>
                <c:ptCount val="7"/>
                <c:pt idx="0">
                  <c:v>0.15748031496063</c:v>
                </c:pt>
                <c:pt idx="1">
                  <c:v>0.425196850393701</c:v>
                </c:pt>
                <c:pt idx="2">
                  <c:v>0.141732283464567</c:v>
                </c:pt>
                <c:pt idx="3">
                  <c:v>0.133858267716535</c:v>
                </c:pt>
                <c:pt idx="4">
                  <c:v>0.0551181102362205</c:v>
                </c:pt>
                <c:pt idx="5">
                  <c:v>0.078740157480315</c:v>
                </c:pt>
                <c:pt idx="6">
                  <c:v>0.0078740157480314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S2_Glyco-nonglyco bins'!$AU$50</c:f>
              <c:strCache>
                <c:ptCount val="1"/>
                <c:pt idx="0">
                  <c:v>Secretor</c:v>
                </c:pt>
              </c:strCache>
            </c:strRef>
          </c:tx>
          <c:cat>
            <c:strRef>
              <c:f>'S2_Glyco-nonglyco bins'!$AS$51:$AS$57</c:f>
              <c:strCache>
                <c:ptCount val="7"/>
                <c:pt idx="0">
                  <c:v>n=1</c:v>
                </c:pt>
                <c:pt idx="1">
                  <c:v>1&lt;n&lt;7</c:v>
                </c:pt>
                <c:pt idx="2">
                  <c:v>7&lt;n&lt;20</c:v>
                </c:pt>
                <c:pt idx="3">
                  <c:v>20&lt;n&lt;50</c:v>
                </c:pt>
                <c:pt idx="4">
                  <c:v>50&lt;n&lt;100</c:v>
                </c:pt>
                <c:pt idx="5">
                  <c:v>100&lt;n&lt;400</c:v>
                </c:pt>
                <c:pt idx="6">
                  <c:v>n&gt;400</c:v>
                </c:pt>
              </c:strCache>
            </c:strRef>
          </c:cat>
          <c:val>
            <c:numRef>
              <c:f>'S2_Glyco-nonglyco bins'!$AU$51:$AU$57</c:f>
              <c:numCache>
                <c:formatCode>General</c:formatCode>
                <c:ptCount val="7"/>
                <c:pt idx="0">
                  <c:v>0.13265306122449</c:v>
                </c:pt>
                <c:pt idx="1">
                  <c:v>0.295918367346939</c:v>
                </c:pt>
                <c:pt idx="2">
                  <c:v>0.244897959183673</c:v>
                </c:pt>
                <c:pt idx="3">
                  <c:v>0.112244897959184</c:v>
                </c:pt>
                <c:pt idx="4">
                  <c:v>0.0816326530612245</c:v>
                </c:pt>
                <c:pt idx="5">
                  <c:v>0.112244897959184</c:v>
                </c:pt>
                <c:pt idx="6">
                  <c:v>0.020408163265306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3067768"/>
        <c:axId val="-2023062008"/>
      </c:lineChart>
      <c:catAx>
        <c:axId val="-2023067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Spectral Count Bins</a:t>
                </a:r>
              </a:p>
            </c:rich>
          </c:tx>
          <c:layout>
            <c:manualLayout>
              <c:xMode val="edge"/>
              <c:yMode val="edge"/>
              <c:x val="0.321262772920468"/>
              <c:y val="0.907491154148003"/>
            </c:manualLayout>
          </c:layout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23062008"/>
        <c:crosses val="autoZero"/>
        <c:auto val="1"/>
        <c:lblAlgn val="ctr"/>
        <c:lblOffset val="100"/>
        <c:noMultiLvlLbl val="0"/>
      </c:catAx>
      <c:valAx>
        <c:axId val="-2023062008"/>
        <c:scaling>
          <c:orientation val="minMax"/>
          <c:max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Bin Occupancy</a:t>
                </a:r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023067768"/>
        <c:crosses val="autoZero"/>
        <c:crossBetween val="between"/>
      </c:valAx>
    </c:plotArea>
    <c:legend>
      <c:legendPos val="t"/>
      <c:layout/>
      <c:overlay val="0"/>
      <c:txPr>
        <a:bodyPr/>
        <a:lstStyle/>
        <a:p>
          <a:pPr>
            <a:defRPr sz="14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S2_Glyco-nonglyco bins'!$AQ$50</c:f>
              <c:strCache>
                <c:ptCount val="1"/>
                <c:pt idx="0">
                  <c:v>Nonsecretor</c:v>
                </c:pt>
              </c:strCache>
            </c:strRef>
          </c:tx>
          <c:spPr>
            <a:ln>
              <a:prstDash val="sysDot"/>
            </a:ln>
          </c:spPr>
          <c:cat>
            <c:strRef>
              <c:f>'S2_Glyco-nonglyco bins'!$AP$51:$AP$57</c:f>
              <c:strCache>
                <c:ptCount val="7"/>
                <c:pt idx="0">
                  <c:v>n=1</c:v>
                </c:pt>
                <c:pt idx="1">
                  <c:v>1&lt;n&lt;7</c:v>
                </c:pt>
                <c:pt idx="2">
                  <c:v>7&lt;n&lt;20</c:v>
                </c:pt>
                <c:pt idx="3">
                  <c:v>20&lt;n&lt;50</c:v>
                </c:pt>
                <c:pt idx="4">
                  <c:v>50&lt;n&lt;100</c:v>
                </c:pt>
                <c:pt idx="5">
                  <c:v>100&lt;n&lt;400</c:v>
                </c:pt>
                <c:pt idx="6">
                  <c:v>n&gt;400</c:v>
                </c:pt>
              </c:strCache>
            </c:strRef>
          </c:cat>
          <c:val>
            <c:numRef>
              <c:f>'S2_Glyco-nonglyco bins'!$AQ$51:$AQ$57</c:f>
              <c:numCache>
                <c:formatCode>General</c:formatCode>
                <c:ptCount val="7"/>
                <c:pt idx="0">
                  <c:v>0.226832641770401</c:v>
                </c:pt>
                <c:pt idx="1">
                  <c:v>0.461502996772706</c:v>
                </c:pt>
                <c:pt idx="2">
                  <c:v>0.159059474412172</c:v>
                </c:pt>
                <c:pt idx="3">
                  <c:v>0.0769940064545874</c:v>
                </c:pt>
                <c:pt idx="4">
                  <c:v>0.0364223144306132</c:v>
                </c:pt>
                <c:pt idx="5">
                  <c:v>0.0299677270631627</c:v>
                </c:pt>
                <c:pt idx="6">
                  <c:v>0.0092208390963577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S2_Glyco-nonglyco bins'!$AR$50</c:f>
              <c:strCache>
                <c:ptCount val="1"/>
                <c:pt idx="0">
                  <c:v>Secretor</c:v>
                </c:pt>
              </c:strCache>
            </c:strRef>
          </c:tx>
          <c:spPr>
            <a:ln>
              <a:prstDash val="sysDot"/>
            </a:ln>
          </c:spPr>
          <c:cat>
            <c:strRef>
              <c:f>'S2_Glyco-nonglyco bins'!$AP$51:$AP$57</c:f>
              <c:strCache>
                <c:ptCount val="7"/>
                <c:pt idx="0">
                  <c:v>n=1</c:v>
                </c:pt>
                <c:pt idx="1">
                  <c:v>1&lt;n&lt;7</c:v>
                </c:pt>
                <c:pt idx="2">
                  <c:v>7&lt;n&lt;20</c:v>
                </c:pt>
                <c:pt idx="3">
                  <c:v>20&lt;n&lt;50</c:v>
                </c:pt>
                <c:pt idx="4">
                  <c:v>50&lt;n&lt;100</c:v>
                </c:pt>
                <c:pt idx="5">
                  <c:v>100&lt;n&lt;400</c:v>
                </c:pt>
                <c:pt idx="6">
                  <c:v>n&gt;400</c:v>
                </c:pt>
              </c:strCache>
            </c:strRef>
          </c:cat>
          <c:val>
            <c:numRef>
              <c:f>'S2_Glyco-nonglyco bins'!$AR$51:$AR$57</c:f>
              <c:numCache>
                <c:formatCode>General</c:formatCode>
                <c:ptCount val="7"/>
                <c:pt idx="0">
                  <c:v>0.256830601092896</c:v>
                </c:pt>
                <c:pt idx="1">
                  <c:v>0.437158469945355</c:v>
                </c:pt>
                <c:pt idx="2">
                  <c:v>0.155737704918033</c:v>
                </c:pt>
                <c:pt idx="3">
                  <c:v>0.080327868852459</c:v>
                </c:pt>
                <c:pt idx="4">
                  <c:v>0.0311475409836066</c:v>
                </c:pt>
                <c:pt idx="5">
                  <c:v>0.0295081967213115</c:v>
                </c:pt>
                <c:pt idx="6">
                  <c:v>0.0092896174863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3181672"/>
        <c:axId val="-2023176136"/>
      </c:lineChart>
      <c:catAx>
        <c:axId val="-20231816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Spectral Count Bins</a:t>
                </a:r>
              </a:p>
            </c:rich>
          </c:tx>
          <c:layout>
            <c:manualLayout>
              <c:xMode val="edge"/>
              <c:yMode val="edge"/>
              <c:x val="0.282740874986856"/>
              <c:y val="0.907491154148003"/>
            </c:manualLayout>
          </c:layout>
          <c:overlay val="0"/>
        </c:title>
        <c:majorTickMark val="out"/>
        <c:minorTickMark val="none"/>
        <c:tickLblPos val="nextTo"/>
        <c:crossAx val="-2023176136"/>
        <c:crosses val="autoZero"/>
        <c:auto val="1"/>
        <c:lblAlgn val="ctr"/>
        <c:lblOffset val="100"/>
        <c:noMultiLvlLbl val="0"/>
      </c:catAx>
      <c:valAx>
        <c:axId val="-20231761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Bin Occupancy</a:t>
                </a:r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crossAx val="-2023181672"/>
        <c:crosses val="autoZero"/>
        <c:crossBetween val="between"/>
      </c:valAx>
    </c:plotArea>
    <c:legend>
      <c:legendPos val="t"/>
      <c:layout/>
      <c:overlay val="0"/>
      <c:txPr>
        <a:bodyPr/>
        <a:lstStyle/>
        <a:p>
          <a:pPr>
            <a:defRPr sz="14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840624-79EC-D34F-9217-BAA8F1A53D32}" type="datetimeFigureOut">
              <a:rPr lang="en-US" smtClean="0"/>
              <a:t>8/1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A77E94-55A0-4D49-B91B-98EF005AF6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946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. S3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013BC0-820D-4C60-A3EC-A45F4E48B43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709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608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391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905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70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107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651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826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468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065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87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697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F41C2-D007-AF44-B422-0FDD99336B28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B8BF9-BECD-CA4B-B045-6B25351496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66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0375" y="1230313"/>
            <a:ext cx="4040188" cy="293687"/>
          </a:xfrm>
        </p:spPr>
        <p:txBody>
          <a:bodyPr>
            <a:normAutofit fontScale="62500" lnSpcReduction="20000"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ycopeptide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8200" y="1230313"/>
            <a:ext cx="4041775" cy="293687"/>
          </a:xfrm>
        </p:spPr>
        <p:txBody>
          <a:bodyPr>
            <a:normAutofit fontScale="62500" lnSpcReduction="20000"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: Non-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ycopeptide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Content Placeholder 9"/>
          <p:cNvGraphicFramePr>
            <a:graphicFrameLocks noGrp="1"/>
          </p:cNvGraphicFramePr>
          <p:nvPr>
            <p:ph sz="half" idx="2"/>
            <p:extLst>
              <p:ext uri="{D42A27DB-BD31-4B8C-83A1-F6EECF244321}">
                <p14:modId xmlns:p14="http://schemas.microsoft.com/office/powerpoint/2010/main" val="1368011952"/>
              </p:ext>
            </p:extLst>
          </p:nvPr>
        </p:nvGraphicFramePr>
        <p:xfrm>
          <a:off x="463550" y="1741488"/>
          <a:ext cx="4040188" cy="3951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ontent Placeholder 12"/>
          <p:cNvGraphicFramePr>
            <a:graphicFrameLocks noGrp="1"/>
          </p:cNvGraphicFramePr>
          <p:nvPr>
            <p:ph sz="quarter" idx="4"/>
            <p:extLst>
              <p:ext uri="{D42A27DB-BD31-4B8C-83A1-F6EECF244321}">
                <p14:modId xmlns:p14="http://schemas.microsoft.com/office/powerpoint/2010/main" val="648509513"/>
              </p:ext>
            </p:extLst>
          </p:nvPr>
        </p:nvGraphicFramePr>
        <p:xfrm>
          <a:off x="4651375" y="1741488"/>
          <a:ext cx="4041775" cy="3951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10659" y="89856"/>
            <a:ext cx="2419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</a:t>
            </a:r>
            <a:r>
              <a:rPr lang="en-US" dirty="0">
                <a:latin typeface="Arial"/>
                <a:cs typeface="Arial"/>
              </a:rPr>
              <a:t>S</a:t>
            </a:r>
            <a:r>
              <a:rPr lang="en-US" dirty="0" smtClean="0">
                <a:latin typeface="Arial"/>
                <a:cs typeface="Arial"/>
              </a:rPr>
              <a:t>3 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029445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Macintosh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Hall</dc:creator>
  <cp:lastModifiedBy>Norma McCormack</cp:lastModifiedBy>
  <cp:revision>5</cp:revision>
  <dcterms:created xsi:type="dcterms:W3CDTF">2015-04-30T15:44:44Z</dcterms:created>
  <dcterms:modified xsi:type="dcterms:W3CDTF">2015-08-19T16:42:48Z</dcterms:modified>
</cp:coreProperties>
</file>